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 showGuides="1">
      <p:cViewPr>
        <p:scale>
          <a:sx n="287" d="100"/>
          <a:sy n="287" d="100"/>
        </p:scale>
        <p:origin x="-952" y="-132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B9FF7-4342-5341-AFE6-18EE3EC928D6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AED15-4B3A-134D-A98B-3E4B6265F95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9270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B9FF7-4342-5341-AFE6-18EE3EC928D6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AED15-4B3A-134D-A98B-3E4B6265F95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1449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B9FF7-4342-5341-AFE6-18EE3EC928D6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AED15-4B3A-134D-A98B-3E4B6265F95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0865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B9FF7-4342-5341-AFE6-18EE3EC928D6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AED15-4B3A-134D-A98B-3E4B6265F95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0127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B9FF7-4342-5341-AFE6-18EE3EC928D6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AED15-4B3A-134D-A98B-3E4B6265F95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6173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B9FF7-4342-5341-AFE6-18EE3EC928D6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AED15-4B3A-134D-A98B-3E4B6265F95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8148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B9FF7-4342-5341-AFE6-18EE3EC928D6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AED15-4B3A-134D-A98B-3E4B6265F95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0889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B9FF7-4342-5341-AFE6-18EE3EC928D6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AED15-4B3A-134D-A98B-3E4B6265F95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6730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B9FF7-4342-5341-AFE6-18EE3EC928D6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AED15-4B3A-134D-A98B-3E4B6265F95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6705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B9FF7-4342-5341-AFE6-18EE3EC928D6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AED15-4B3A-134D-A98B-3E4B6265F95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4146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B9FF7-4342-5341-AFE6-18EE3EC928D6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AED15-4B3A-134D-A98B-3E4B6265F95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70977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AB9FF7-4342-5341-AFE6-18EE3EC928D6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EAED15-4B3A-134D-A98B-3E4B6265F95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5889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1AC8FEDD-0263-5647-8829-74C3598CB7D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06" t="48526" r="33149" b="36209"/>
          <a:stretch/>
        </p:blipFill>
        <p:spPr>
          <a:xfrm>
            <a:off x="2027004" y="2753248"/>
            <a:ext cx="2700170" cy="720762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E45B2198-620A-7047-9466-19D89F0A1D0D}"/>
              </a:ext>
            </a:extLst>
          </p:cNvPr>
          <p:cNvSpPr txBox="1"/>
          <p:nvPr/>
        </p:nvSpPr>
        <p:spPr>
          <a:xfrm rot="18593406">
            <a:off x="2150058" y="2330229"/>
            <a:ext cx="5517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0 HOI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4851FDF-E00D-D54F-9BF6-7ACC90D9D814}"/>
              </a:ext>
            </a:extLst>
          </p:cNvPr>
          <p:cNvSpPr txBox="1"/>
          <p:nvPr/>
        </p:nvSpPr>
        <p:spPr>
          <a:xfrm rot="18593406">
            <a:off x="2547693" y="2331327"/>
            <a:ext cx="5517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6 HOI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058B72A-8820-C64F-93E1-226CF4452574}"/>
              </a:ext>
            </a:extLst>
          </p:cNvPr>
          <p:cNvSpPr txBox="1"/>
          <p:nvPr/>
        </p:nvSpPr>
        <p:spPr>
          <a:xfrm rot="18593406">
            <a:off x="3199393" y="2131578"/>
            <a:ext cx="11336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4 DOS + 0 HOI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DC2D2495-3527-164C-92EA-AC4D233DF355}"/>
              </a:ext>
            </a:extLst>
          </p:cNvPr>
          <p:cNvSpPr txBox="1"/>
          <p:nvPr/>
        </p:nvSpPr>
        <p:spPr>
          <a:xfrm rot="18593406">
            <a:off x="3627155" y="2128415"/>
            <a:ext cx="11336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4 DOS + 6 HOI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030B66AE-E276-BF49-814A-714163798052}"/>
              </a:ext>
            </a:extLst>
          </p:cNvPr>
          <p:cNvSpPr txBox="1"/>
          <p:nvPr/>
        </p:nvSpPr>
        <p:spPr>
          <a:xfrm rot="18593406">
            <a:off x="2922743" y="2298765"/>
            <a:ext cx="6303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24 HOI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E645364-F991-DB41-A176-A60D86FC12F0}"/>
              </a:ext>
            </a:extLst>
          </p:cNvPr>
          <p:cNvSpPr txBox="1"/>
          <p:nvPr/>
        </p:nvSpPr>
        <p:spPr>
          <a:xfrm rot="18593406">
            <a:off x="4031722" y="2098443"/>
            <a:ext cx="12121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4 DOS + 24 HOI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10AB4245-8727-324E-9841-08E3E1E65DBF}"/>
              </a:ext>
            </a:extLst>
          </p:cNvPr>
          <p:cNvSpPr txBox="1"/>
          <p:nvPr/>
        </p:nvSpPr>
        <p:spPr>
          <a:xfrm>
            <a:off x="4718053" y="3030828"/>
            <a:ext cx="925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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tubulin </a:t>
            </a:r>
            <a:endParaRPr lang="fr-FR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id="{238A7C9E-40BC-5144-91C2-914E52D797D2}"/>
              </a:ext>
            </a:extLst>
          </p:cNvPr>
          <p:cNvCxnSpPr/>
          <p:nvPr/>
        </p:nvCxnSpPr>
        <p:spPr>
          <a:xfrm flipV="1">
            <a:off x="3865929" y="1792755"/>
            <a:ext cx="1224000" cy="40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8431E62B-5BC5-D84A-9562-E40933B218B5}"/>
              </a:ext>
            </a:extLst>
          </p:cNvPr>
          <p:cNvCxnSpPr/>
          <p:nvPr/>
        </p:nvCxnSpPr>
        <p:spPr>
          <a:xfrm flipV="1">
            <a:off x="2416344" y="2186550"/>
            <a:ext cx="972000" cy="40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ZoneTexte 13">
            <a:extLst>
              <a:ext uri="{FF2B5EF4-FFF2-40B4-BE49-F238E27FC236}">
                <a16:creationId xmlns:a16="http://schemas.microsoft.com/office/drawing/2014/main" id="{5A24A98B-190D-384C-8349-E7E891AE6C85}"/>
              </a:ext>
            </a:extLst>
          </p:cNvPr>
          <p:cNvSpPr txBox="1"/>
          <p:nvPr/>
        </p:nvSpPr>
        <p:spPr>
          <a:xfrm>
            <a:off x="2332406" y="1931211"/>
            <a:ext cx="11400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Dormant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seeds</a:t>
            </a:r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E31F989C-BC47-BE47-A59F-F997BDBAF8C4}"/>
              </a:ext>
            </a:extLst>
          </p:cNvPr>
          <p:cNvSpPr txBox="1"/>
          <p:nvPr/>
        </p:nvSpPr>
        <p:spPr>
          <a:xfrm>
            <a:off x="3765219" y="1534971"/>
            <a:ext cx="14221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Non-dormant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seeds</a:t>
            </a:r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148D6C5-E05A-6C46-AE50-B7D2EC63BF80}"/>
              </a:ext>
            </a:extLst>
          </p:cNvPr>
          <p:cNvSpPr/>
          <p:nvPr/>
        </p:nvSpPr>
        <p:spPr>
          <a:xfrm>
            <a:off x="1000193" y="4003681"/>
            <a:ext cx="5080352" cy="12795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. S3.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mmunodetection of 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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ubulin.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 5 </a:t>
            </a:r>
            <a:r>
              <a:rPr lang="fr-FR" sz="1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 aliquot of total protein was loaded on each lane and </a:t>
            </a:r>
            <a:r>
              <a:rPr lang="fr-FR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α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tubulin was detected with </a:t>
            </a:r>
            <a:r>
              <a:rPr lang="fr-FR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α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tubulin antibody in dormant and non-dormant </a:t>
            </a:r>
            <a:r>
              <a:rPr lang="en-US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rabidopsis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eeds.</a:t>
            </a:r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OI, hours of imbibition at 25</a:t>
            </a:r>
            <a:r>
              <a:rPr lang="en-US" sz="10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℃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the dark; DOS, days of stratification at 4</a:t>
            </a:r>
            <a:r>
              <a:rPr lang="en-US" sz="10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℃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the dark</a:t>
            </a:r>
            <a:r>
              <a:rPr lang="en-US" sz="10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</a:t>
            </a:r>
            <a:endParaRPr lang="fr-FR" sz="10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529498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89</Words>
  <Application>Microsoft Macintosh PowerPoint</Application>
  <PresentationFormat>Format A4 (210 x 297 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ristophe bailly</dc:creator>
  <cp:lastModifiedBy>christophe bailly</cp:lastModifiedBy>
  <cp:revision>2</cp:revision>
  <dcterms:created xsi:type="dcterms:W3CDTF">2020-03-05T13:59:06Z</dcterms:created>
  <dcterms:modified xsi:type="dcterms:W3CDTF">2020-03-09T10:10:44Z</dcterms:modified>
</cp:coreProperties>
</file>